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E32448-731F-4612-BFAE-67F2B704DBC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6A6973-FCEA-4904-B983-5823FA5F6C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950A4D-AC22-43DD-A572-3A6693A3560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ABB18C-941B-4A55-98E0-1D1D18E6DB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990BA-ECBE-4624-A7D5-1DD2C257AB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56BC7C-7785-43A4-A2EE-38C2E369AC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A57F30-D5E2-4FC0-814E-18CE2373B2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17C586-F2BF-48AD-8621-8AC18AC737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84BE92-15CC-4AE8-A571-F3A4F2B6CA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B3265A-6290-4695-BDBB-385BDE5BAE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C754E8-D234-402C-A5EC-5AEBAEDBC5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125D5-2448-475F-9098-99C067B3AE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l-P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1E1AB12-A602-4C31-A8BB-8B769108E776}" type="slidenum">
              <a:rPr b="0" lang="pl-P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Obraz 4" descr=""/>
          <p:cNvPicPr/>
          <p:nvPr/>
        </p:nvPicPr>
        <p:blipFill>
          <a:blip r:embed="rId1"/>
          <a:srcRect l="0" t="8945" r="86099" b="22916"/>
          <a:stretch/>
        </p:blipFill>
        <p:spPr>
          <a:xfrm>
            <a:off x="1300320" y="1663560"/>
            <a:ext cx="1236600" cy="3232440"/>
          </a:xfrm>
          <a:prstGeom prst="rect">
            <a:avLst/>
          </a:prstGeom>
          <a:ln w="0">
            <a:noFill/>
          </a:ln>
        </p:spPr>
      </p:pic>
      <p:sp>
        <p:nvSpPr>
          <p:cNvPr id="42" name="pole tekstowe 5"/>
          <p:cNvSpPr/>
          <p:nvPr/>
        </p:nvSpPr>
        <p:spPr>
          <a:xfrm>
            <a:off x="2429280" y="871560"/>
            <a:ext cx="429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100" spc="-1" strike="noStrike">
                <a:solidFill>
                  <a:srgbClr val="000000"/>
                </a:solidFill>
                <a:latin typeface="Arial"/>
              </a:rPr>
              <a:t>B1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ole tekstowe 6"/>
          <p:cNvSpPr/>
          <p:nvPr/>
        </p:nvSpPr>
        <p:spPr>
          <a:xfrm>
            <a:off x="2959560" y="871560"/>
            <a:ext cx="848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100" spc="-1" strike="noStrike">
                <a:solidFill>
                  <a:srgbClr val="000000"/>
                </a:solidFill>
                <a:latin typeface="Arial"/>
              </a:rPr>
              <a:t>B16Ep63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Łącznik prosty 10"/>
          <p:cNvSpPr/>
          <p:nvPr/>
        </p:nvSpPr>
        <p:spPr>
          <a:xfrm>
            <a:off x="1189080" y="1133640"/>
            <a:ext cx="26258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ole tekstowe 11"/>
          <p:cNvSpPr/>
          <p:nvPr/>
        </p:nvSpPr>
        <p:spPr>
          <a:xfrm>
            <a:off x="1375920" y="868320"/>
            <a:ext cx="467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100" spc="-1" strike="noStrike">
                <a:solidFill>
                  <a:srgbClr val="000000"/>
                </a:solidFill>
                <a:latin typeface="Arial"/>
              </a:rPr>
              <a:t>TC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ole tekstowe 13"/>
          <p:cNvSpPr/>
          <p:nvPr/>
        </p:nvSpPr>
        <p:spPr>
          <a:xfrm>
            <a:off x="2692440" y="557280"/>
            <a:ext cx="94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NFAT-G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Łącznik prosty 15"/>
          <p:cNvSpPr/>
          <p:nvPr/>
        </p:nvSpPr>
        <p:spPr>
          <a:xfrm>
            <a:off x="2513160" y="779400"/>
            <a:ext cx="1301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ole tekstowe 17"/>
          <p:cNvSpPr/>
          <p:nvPr/>
        </p:nvSpPr>
        <p:spPr>
          <a:xfrm>
            <a:off x="2471040" y="110664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-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ole tekstowe 18"/>
          <p:cNvSpPr/>
          <p:nvPr/>
        </p:nvSpPr>
        <p:spPr>
          <a:xfrm>
            <a:off x="2475000" y="136836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-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ole tekstowe 19"/>
          <p:cNvSpPr/>
          <p:nvPr/>
        </p:nvSpPr>
        <p:spPr>
          <a:xfrm>
            <a:off x="2464920" y="161460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ole tekstowe 20"/>
          <p:cNvSpPr/>
          <p:nvPr/>
        </p:nvSpPr>
        <p:spPr>
          <a:xfrm>
            <a:off x="2469600" y="185256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ole tekstowe 21"/>
          <p:cNvSpPr/>
          <p:nvPr/>
        </p:nvSpPr>
        <p:spPr>
          <a:xfrm>
            <a:off x="2472840" y="210348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ole tekstowe 22"/>
          <p:cNvSpPr/>
          <p:nvPr/>
        </p:nvSpPr>
        <p:spPr>
          <a:xfrm>
            <a:off x="2472840" y="231948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ole tekstowe 23"/>
          <p:cNvSpPr/>
          <p:nvPr/>
        </p:nvSpPr>
        <p:spPr>
          <a:xfrm>
            <a:off x="2476800" y="255888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ole tekstowe 24"/>
          <p:cNvSpPr/>
          <p:nvPr/>
        </p:nvSpPr>
        <p:spPr>
          <a:xfrm>
            <a:off x="2479680" y="280980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ole tekstowe 25"/>
          <p:cNvSpPr/>
          <p:nvPr/>
        </p:nvSpPr>
        <p:spPr>
          <a:xfrm>
            <a:off x="2486160" y="303516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ole tekstowe 26"/>
          <p:cNvSpPr/>
          <p:nvPr/>
        </p:nvSpPr>
        <p:spPr>
          <a:xfrm>
            <a:off x="2490840" y="327348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ole tekstowe 27"/>
          <p:cNvSpPr/>
          <p:nvPr/>
        </p:nvSpPr>
        <p:spPr>
          <a:xfrm>
            <a:off x="2493360" y="352440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ole tekstowe 28"/>
          <p:cNvSpPr/>
          <p:nvPr/>
        </p:nvSpPr>
        <p:spPr>
          <a:xfrm>
            <a:off x="2493360" y="374184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ole tekstowe 29"/>
          <p:cNvSpPr/>
          <p:nvPr/>
        </p:nvSpPr>
        <p:spPr>
          <a:xfrm>
            <a:off x="2498040" y="397980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ole tekstowe 30"/>
          <p:cNvSpPr/>
          <p:nvPr/>
        </p:nvSpPr>
        <p:spPr>
          <a:xfrm>
            <a:off x="2500560" y="423072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ole tekstowe 31"/>
          <p:cNvSpPr/>
          <p:nvPr/>
        </p:nvSpPr>
        <p:spPr>
          <a:xfrm>
            <a:off x="2502000" y="4464000"/>
            <a:ext cx="1183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Grupa 37"/>
          <p:cNvGrpSpPr/>
          <p:nvPr/>
        </p:nvGrpSpPr>
        <p:grpSpPr>
          <a:xfrm>
            <a:off x="5538960" y="301680"/>
            <a:ext cx="4493880" cy="4664880"/>
            <a:chOff x="5538960" y="301680"/>
            <a:chExt cx="4493880" cy="4664880"/>
          </a:xfrm>
        </p:grpSpPr>
        <p:grpSp>
          <p:nvGrpSpPr>
            <p:cNvPr id="64" name="Grupa 228"/>
            <p:cNvGrpSpPr/>
            <p:nvPr/>
          </p:nvGrpSpPr>
          <p:grpSpPr>
            <a:xfrm>
              <a:off x="5538960" y="301680"/>
              <a:ext cx="4493880" cy="4664880"/>
              <a:chOff x="5538960" y="301680"/>
              <a:chExt cx="4493880" cy="4664880"/>
            </a:xfrm>
          </p:grpSpPr>
          <p:grpSp>
            <p:nvGrpSpPr>
              <p:cNvPr id="65" name="Grupa 227"/>
              <p:cNvGrpSpPr/>
              <p:nvPr/>
            </p:nvGrpSpPr>
            <p:grpSpPr>
              <a:xfrm>
                <a:off x="5538960" y="301680"/>
                <a:ext cx="4493880" cy="4664880"/>
                <a:chOff x="5538960" y="301680"/>
                <a:chExt cx="4493880" cy="4664880"/>
              </a:xfrm>
            </p:grpSpPr>
            <p:pic>
              <p:nvPicPr>
                <p:cNvPr id="66" name="Picture 2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6389640" y="1596240"/>
                  <a:ext cx="3412440" cy="2165400"/>
                </a:xfrm>
                <a:prstGeom prst="rect">
                  <a:avLst/>
                </a:prstGeom>
                <a:ln w="0">
                  <a:noFill/>
                </a:ln>
              </p:spPr>
            </p:pic>
            <p:grpSp>
              <p:nvGrpSpPr>
                <p:cNvPr id="67" name="Grupa 48"/>
                <p:cNvGrpSpPr/>
                <p:nvPr/>
              </p:nvGrpSpPr>
              <p:grpSpPr>
                <a:xfrm>
                  <a:off x="5538960" y="3034080"/>
                  <a:ext cx="4493880" cy="1932480"/>
                  <a:chOff x="5538960" y="3034080"/>
                  <a:chExt cx="4493880" cy="1932480"/>
                </a:xfrm>
              </p:grpSpPr>
              <p:sp>
                <p:nvSpPr>
                  <p:cNvPr id="68" name="pole tekstowe 49"/>
                  <p:cNvSpPr/>
                  <p:nvPr/>
                </p:nvSpPr>
                <p:spPr>
                  <a:xfrm rot="19096200">
                    <a:off x="7452000" y="3870720"/>
                    <a:ext cx="2016360" cy="2311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pl-PL" sz="900" spc="-1" strike="noStrike">
                        <a:solidFill>
                          <a:srgbClr val="000000"/>
                        </a:solidFill>
                        <a:latin typeface="Arial"/>
                      </a:rPr>
                      <a:t>TYFCAARPYTGGLS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69" name="Grupa 47"/>
                  <p:cNvGrpSpPr/>
                  <p:nvPr/>
                </p:nvGrpSpPr>
                <p:grpSpPr>
                  <a:xfrm>
                    <a:off x="5538960" y="3034080"/>
                    <a:ext cx="4493880" cy="1932480"/>
                    <a:chOff x="5538960" y="3034080"/>
                    <a:chExt cx="4493880" cy="1932480"/>
                  </a:xfrm>
                </p:grpSpPr>
                <p:sp>
                  <p:nvSpPr>
                    <p:cNvPr id="70" name="pole tekstowe 51"/>
                    <p:cNvSpPr/>
                    <p:nvPr/>
                  </p:nvSpPr>
                  <p:spPr>
                    <a:xfrm rot="19077600">
                      <a:off x="5376600" y="3985920"/>
                      <a:ext cx="186120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FCAVVDSNYQLIW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1" name="pole tekstowe 9"/>
                    <p:cNvSpPr/>
                    <p:nvPr/>
                  </p:nvSpPr>
                  <p:spPr>
                    <a:xfrm rot="19067400">
                      <a:off x="5520240" y="3936240"/>
                      <a:ext cx="201636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FCAASDSNYQLIW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2" name="pole tekstowe 53"/>
                    <p:cNvSpPr/>
                    <p:nvPr/>
                  </p:nvSpPr>
                  <p:spPr>
                    <a:xfrm rot="19080600">
                      <a:off x="5694840" y="3938040"/>
                      <a:ext cx="201636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FCAASASNYQLIW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3" name="pole tekstowe 11"/>
                    <p:cNvSpPr/>
                    <p:nvPr/>
                  </p:nvSpPr>
                  <p:spPr>
                    <a:xfrm rot="19074600">
                      <a:off x="5896440" y="3932280"/>
                      <a:ext cx="201636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FCAASESNYQLIW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4" name="pole tekstowe 55"/>
                    <p:cNvSpPr/>
                    <p:nvPr/>
                  </p:nvSpPr>
                  <p:spPr>
                    <a:xfrm rot="19105200">
                      <a:off x="6079320" y="3931200"/>
                      <a:ext cx="201636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FCAASEGNYQLIW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5" name="pole tekstowe 56"/>
                    <p:cNvSpPr/>
                    <p:nvPr/>
                  </p:nvSpPr>
                  <p:spPr>
                    <a:xfrm rot="19086600">
                      <a:off x="6261480" y="3944160"/>
                      <a:ext cx="201636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TYFCAASEGAGGL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6" name="pole tekstowe 57"/>
                    <p:cNvSpPr/>
                    <p:nvPr/>
                  </p:nvSpPr>
                  <p:spPr>
                    <a:xfrm rot="19096800">
                      <a:off x="6462720" y="3925440"/>
                      <a:ext cx="201636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FCAAVDSNYQLIW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7" name="pole tekstowe 58"/>
                    <p:cNvSpPr/>
                    <p:nvPr/>
                  </p:nvSpPr>
                  <p:spPr>
                    <a:xfrm rot="19098600">
                      <a:off x="6770520" y="3835440"/>
                      <a:ext cx="201636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TYFCAAPGTGGL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8" name="pole tekstowe 59"/>
                    <p:cNvSpPr/>
                    <p:nvPr/>
                  </p:nvSpPr>
                  <p:spPr>
                    <a:xfrm rot="19080600">
                      <a:off x="7015680" y="3772440"/>
                      <a:ext cx="201636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FCAARGGGL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9" name="pole tekstowe 60"/>
                    <p:cNvSpPr/>
                    <p:nvPr/>
                  </p:nvSpPr>
                  <p:spPr>
                    <a:xfrm rot="19080000">
                      <a:off x="6931800" y="4006080"/>
                      <a:ext cx="201636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FCAASPDSNYQLIW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0" name="pole tekstowe 61"/>
                    <p:cNvSpPr/>
                    <p:nvPr/>
                  </p:nvSpPr>
                  <p:spPr>
                    <a:xfrm rot="19090800">
                      <a:off x="7178040" y="3946320"/>
                      <a:ext cx="201636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FCAMVDSNYQLIW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1" name="pole tekstowe 62"/>
                    <p:cNvSpPr/>
                    <p:nvPr/>
                  </p:nvSpPr>
                  <p:spPr>
                    <a:xfrm rot="19033200">
                      <a:off x="7349760" y="4002120"/>
                      <a:ext cx="224928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FCAASAKGSNYQLIW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2" name="pole tekstowe 63"/>
                    <p:cNvSpPr/>
                    <p:nvPr/>
                  </p:nvSpPr>
                  <p:spPr>
                    <a:xfrm rot="18987600">
                      <a:off x="7764840" y="3776760"/>
                      <a:ext cx="224928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FCAESSNYQLIW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" name="pole tekstowe 64"/>
                    <p:cNvSpPr/>
                    <p:nvPr/>
                  </p:nvSpPr>
                  <p:spPr>
                    <a:xfrm rot="18987000">
                      <a:off x="7770240" y="3936240"/>
                      <a:ext cx="224928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FCAASASSNYQLIW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4" name="pole tekstowe 65"/>
                    <p:cNvSpPr/>
                    <p:nvPr/>
                  </p:nvSpPr>
                  <p:spPr>
                    <a:xfrm rot="18954000">
                      <a:off x="8019720" y="3858480"/>
                      <a:ext cx="224928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FCAASGANTGGL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5" name="pole tekstowe 66"/>
                    <p:cNvSpPr/>
                    <p:nvPr/>
                  </p:nvSpPr>
                  <p:spPr>
                    <a:xfrm rot="18878400">
                      <a:off x="8560800" y="3974040"/>
                      <a:ext cx="1279080" cy="2311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l-P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S 55 (Control +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sp>
              <p:nvSpPr>
                <p:cNvPr id="86" name="pole tekstowe 48"/>
                <p:cNvSpPr/>
                <p:nvPr/>
              </p:nvSpPr>
              <p:spPr>
                <a:xfrm rot="16200000">
                  <a:off x="4412160" y="1738080"/>
                  <a:ext cx="31190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pl-PL" sz="1000" spc="-1" strike="noStrike">
                      <a:solidFill>
                        <a:srgbClr val="000000"/>
                      </a:solidFill>
                      <a:latin typeface="Arial"/>
                    </a:rPr>
                    <a:t>Production of IL-2 (pg/ml)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7" name="Prostokąt 45"/>
              <p:cNvSpPr/>
              <p:nvPr/>
            </p:nvSpPr>
            <p:spPr>
              <a:xfrm>
                <a:off x="7940880" y="1663920"/>
                <a:ext cx="1163520" cy="1918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8" name="pole tekstowe 39"/>
            <p:cNvSpPr/>
            <p:nvPr/>
          </p:nvSpPr>
          <p:spPr>
            <a:xfrm rot="18878400">
              <a:off x="8763480" y="3984120"/>
              <a:ext cx="1279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l-PL" sz="900" spc="-1" strike="noStrike">
                  <a:solidFill>
                    <a:srgbClr val="000000"/>
                  </a:solidFill>
                  <a:latin typeface="Arial"/>
                </a:rPr>
                <a:t>BS 55 (Control -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9" name="pole tekstowe 67"/>
          <p:cNvSpPr/>
          <p:nvPr/>
        </p:nvSpPr>
        <p:spPr>
          <a:xfrm>
            <a:off x="6175800" y="33386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ole tekstowe 68"/>
          <p:cNvSpPr/>
          <p:nvPr/>
        </p:nvSpPr>
        <p:spPr>
          <a:xfrm>
            <a:off x="6118920" y="30718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pole tekstowe 69"/>
          <p:cNvSpPr/>
          <p:nvPr/>
        </p:nvSpPr>
        <p:spPr>
          <a:xfrm>
            <a:off x="6126840" y="25430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ole tekstowe 70"/>
          <p:cNvSpPr/>
          <p:nvPr/>
        </p:nvSpPr>
        <p:spPr>
          <a:xfrm>
            <a:off x="6118920" y="280980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ole tekstowe 71"/>
          <p:cNvSpPr/>
          <p:nvPr/>
        </p:nvSpPr>
        <p:spPr>
          <a:xfrm>
            <a:off x="6130800" y="22892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pole tekstowe 72"/>
          <p:cNvSpPr/>
          <p:nvPr/>
        </p:nvSpPr>
        <p:spPr>
          <a:xfrm>
            <a:off x="6140880" y="20210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pole tekstowe 73"/>
          <p:cNvSpPr/>
          <p:nvPr/>
        </p:nvSpPr>
        <p:spPr>
          <a:xfrm>
            <a:off x="6140880" y="17636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pole tekstowe 74"/>
          <p:cNvSpPr/>
          <p:nvPr/>
        </p:nvSpPr>
        <p:spPr>
          <a:xfrm>
            <a:off x="6140880" y="151272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ole tekstowe 75"/>
          <p:cNvSpPr/>
          <p:nvPr/>
        </p:nvSpPr>
        <p:spPr>
          <a:xfrm>
            <a:off x="1042920" y="5267160"/>
            <a:ext cx="10623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2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200" spc="-1" strike="noStrike">
                <a:solidFill>
                  <a:srgbClr val="000000"/>
                </a:solidFill>
                <a:latin typeface="Arial"/>
              </a:rPr>
              <a:t>Reactivity of selected hybridoma TCRs toward B16 or B16Ep63K (red-colored) assessed by induction of NFAT-GFP expression (a) or secretion of IL-2 (b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ole tekstowe 76"/>
          <p:cNvSpPr/>
          <p:nvPr/>
        </p:nvSpPr>
        <p:spPr>
          <a:xfrm>
            <a:off x="460080" y="76824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ole tekstowe 77"/>
          <p:cNvSpPr/>
          <p:nvPr/>
        </p:nvSpPr>
        <p:spPr>
          <a:xfrm>
            <a:off x="5462280" y="76824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pole tekstowe 78"/>
          <p:cNvSpPr/>
          <p:nvPr/>
        </p:nvSpPr>
        <p:spPr>
          <a:xfrm>
            <a:off x="1216080" y="1185840"/>
            <a:ext cx="2016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ff0000"/>
                </a:solidFill>
                <a:latin typeface="Arial"/>
              </a:rPr>
              <a:t>TYFCAASEGAGGL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ole tekstowe 79"/>
          <p:cNvSpPr/>
          <p:nvPr/>
        </p:nvSpPr>
        <p:spPr>
          <a:xfrm>
            <a:off x="1220760" y="1433520"/>
            <a:ext cx="2016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l-PL" sz="700" spc="-1" strike="noStrike">
                <a:solidFill>
                  <a:srgbClr val="ff0000"/>
                </a:solidFill>
                <a:latin typeface="Arial"/>
              </a:rPr>
              <a:t>TYFCAAPGTGGL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0-10T14:37:29Z</dcterms:created>
  <dc:creator>E460</dc:creator>
  <dc:description/>
  <dc:language>en-US</dc:language>
  <cp:lastModifiedBy>0004394</cp:lastModifiedBy>
  <dcterms:modified xsi:type="dcterms:W3CDTF">2017-06-07T02:42:46Z</dcterms:modified>
  <cp:revision>11</cp:revision>
  <dc:subject/>
  <dc:title>Prezentacja programu PowerPoint</dc:title>
</cp:coreProperties>
</file>